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29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702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688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9171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0540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57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4163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1824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969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38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6179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6592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5095-9F74-43FB-8028-BADB47E7CA79}" type="datetimeFigureOut">
              <a:rPr lang="de-DE" smtClean="0"/>
              <a:t>07.09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9FA6F-B0B6-4156-8087-4836492BFD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9068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0187" y="2652387"/>
            <a:ext cx="5762156" cy="3790239"/>
          </a:xfrm>
          <a:prstGeom prst="rect">
            <a:avLst/>
          </a:prstGeom>
        </p:spPr>
      </p:pic>
      <p:sp>
        <p:nvSpPr>
          <p:cNvPr id="6" name="Rechteck 5"/>
          <p:cNvSpPr/>
          <p:nvPr/>
        </p:nvSpPr>
        <p:spPr>
          <a:xfrm>
            <a:off x="123825" y="563336"/>
            <a:ext cx="11764736" cy="13336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kern="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wth characteristics of </a:t>
            </a:r>
            <a:r>
              <a:rPr lang="en-US" sz="1600" b="1" i="1" kern="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anomassiliicoccus luminyensis</a:t>
            </a:r>
            <a:r>
              <a:rPr lang="en-US" sz="1600" b="1" kern="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expression of methyltransferase encoding genes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de-DE" sz="14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na </a:t>
            </a:r>
            <a:r>
              <a:rPr lang="de-DE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öninger</a:t>
            </a:r>
            <a:r>
              <a:rPr lang="de-DE" sz="14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acqueline Gottschling, Uwe Deppenmeier</a:t>
            </a:r>
            <a:endParaRPr lang="de-DE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de-DE" sz="1400" dirty="0">
                <a:latin typeface="Arial" panose="020B0604020202020204" pitchFamily="34" charset="0"/>
                <a:ea typeface="Calibri" panose="020F0502020204030204" pitchFamily="34" charset="0"/>
              </a:rPr>
              <a:t>Institut für Mikrobiologie und Biotechnologie, Universität Bonn, Germany.</a:t>
            </a:r>
            <a:endParaRPr lang="de-DE" sz="1400" dirty="0"/>
          </a:p>
        </p:txBody>
      </p:sp>
      <p:sp>
        <p:nvSpPr>
          <p:cNvPr id="7" name="Textfeld 6"/>
          <p:cNvSpPr txBox="1"/>
          <p:nvPr/>
        </p:nvSpPr>
        <p:spPr>
          <a:xfrm>
            <a:off x="123825" y="194004"/>
            <a:ext cx="2446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material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854611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3108326" y="1474788"/>
            <a:ext cx="5975350" cy="3913188"/>
            <a:chOff x="3108326" y="1474788"/>
            <a:chExt cx="5975350" cy="3913188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3113088" y="1474788"/>
              <a:ext cx="5965825" cy="3908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3108326" y="1479551"/>
              <a:ext cx="5975350" cy="39084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" name="Freeform 6"/>
            <p:cNvSpPr>
              <a:spLocks noEditPoints="1"/>
            </p:cNvSpPr>
            <p:nvPr/>
          </p:nvSpPr>
          <p:spPr bwMode="auto">
            <a:xfrm>
              <a:off x="4257676" y="2317751"/>
              <a:ext cx="4449763" cy="2457450"/>
            </a:xfrm>
            <a:custGeom>
              <a:avLst/>
              <a:gdLst>
                <a:gd name="T0" fmla="*/ 0 w 2803"/>
                <a:gd name="T1" fmla="*/ 1280 h 1548"/>
                <a:gd name="T2" fmla="*/ 206 w 2803"/>
                <a:gd name="T3" fmla="*/ 1280 h 1548"/>
                <a:gd name="T4" fmla="*/ 206 w 2803"/>
                <a:gd name="T5" fmla="*/ 1548 h 1548"/>
                <a:gd name="T6" fmla="*/ 0 w 2803"/>
                <a:gd name="T7" fmla="*/ 1548 h 1548"/>
                <a:gd name="T8" fmla="*/ 0 w 2803"/>
                <a:gd name="T9" fmla="*/ 1280 h 1548"/>
                <a:gd name="T10" fmla="*/ 515 w 2803"/>
                <a:gd name="T11" fmla="*/ 1028 h 1548"/>
                <a:gd name="T12" fmla="*/ 726 w 2803"/>
                <a:gd name="T13" fmla="*/ 1028 h 1548"/>
                <a:gd name="T14" fmla="*/ 726 w 2803"/>
                <a:gd name="T15" fmla="*/ 1548 h 1548"/>
                <a:gd name="T16" fmla="*/ 515 w 2803"/>
                <a:gd name="T17" fmla="*/ 1548 h 1548"/>
                <a:gd name="T18" fmla="*/ 515 w 2803"/>
                <a:gd name="T19" fmla="*/ 1028 h 1548"/>
                <a:gd name="T20" fmla="*/ 1035 w 2803"/>
                <a:gd name="T21" fmla="*/ 737 h 1548"/>
                <a:gd name="T22" fmla="*/ 1241 w 2803"/>
                <a:gd name="T23" fmla="*/ 737 h 1548"/>
                <a:gd name="T24" fmla="*/ 1241 w 2803"/>
                <a:gd name="T25" fmla="*/ 1548 h 1548"/>
                <a:gd name="T26" fmla="*/ 1035 w 2803"/>
                <a:gd name="T27" fmla="*/ 1548 h 1548"/>
                <a:gd name="T28" fmla="*/ 1035 w 2803"/>
                <a:gd name="T29" fmla="*/ 737 h 1548"/>
                <a:gd name="T30" fmla="*/ 1556 w 2803"/>
                <a:gd name="T31" fmla="*/ 554 h 1548"/>
                <a:gd name="T32" fmla="*/ 1761 w 2803"/>
                <a:gd name="T33" fmla="*/ 554 h 1548"/>
                <a:gd name="T34" fmla="*/ 1761 w 2803"/>
                <a:gd name="T35" fmla="*/ 1548 h 1548"/>
                <a:gd name="T36" fmla="*/ 1556 w 2803"/>
                <a:gd name="T37" fmla="*/ 1548 h 1548"/>
                <a:gd name="T38" fmla="*/ 1556 w 2803"/>
                <a:gd name="T39" fmla="*/ 554 h 1548"/>
                <a:gd name="T40" fmla="*/ 2076 w 2803"/>
                <a:gd name="T41" fmla="*/ 12 h 1548"/>
                <a:gd name="T42" fmla="*/ 2282 w 2803"/>
                <a:gd name="T43" fmla="*/ 12 h 1548"/>
                <a:gd name="T44" fmla="*/ 2282 w 2803"/>
                <a:gd name="T45" fmla="*/ 1548 h 1548"/>
                <a:gd name="T46" fmla="*/ 2076 w 2803"/>
                <a:gd name="T47" fmla="*/ 1548 h 1548"/>
                <a:gd name="T48" fmla="*/ 2076 w 2803"/>
                <a:gd name="T49" fmla="*/ 12 h 1548"/>
                <a:gd name="T50" fmla="*/ 2591 w 2803"/>
                <a:gd name="T51" fmla="*/ 0 h 1548"/>
                <a:gd name="T52" fmla="*/ 2803 w 2803"/>
                <a:gd name="T53" fmla="*/ 0 h 1548"/>
                <a:gd name="T54" fmla="*/ 2803 w 2803"/>
                <a:gd name="T55" fmla="*/ 1548 h 1548"/>
                <a:gd name="T56" fmla="*/ 2591 w 2803"/>
                <a:gd name="T57" fmla="*/ 1548 h 1548"/>
                <a:gd name="T58" fmla="*/ 2591 w 2803"/>
                <a:gd name="T59" fmla="*/ 0 h 15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803" h="1548">
                  <a:moveTo>
                    <a:pt x="0" y="1280"/>
                  </a:moveTo>
                  <a:lnTo>
                    <a:pt x="206" y="1280"/>
                  </a:lnTo>
                  <a:lnTo>
                    <a:pt x="206" y="1548"/>
                  </a:lnTo>
                  <a:lnTo>
                    <a:pt x="0" y="1548"/>
                  </a:lnTo>
                  <a:lnTo>
                    <a:pt x="0" y="1280"/>
                  </a:lnTo>
                  <a:close/>
                  <a:moveTo>
                    <a:pt x="515" y="1028"/>
                  </a:moveTo>
                  <a:lnTo>
                    <a:pt x="726" y="1028"/>
                  </a:lnTo>
                  <a:lnTo>
                    <a:pt x="726" y="1548"/>
                  </a:lnTo>
                  <a:lnTo>
                    <a:pt x="515" y="1548"/>
                  </a:lnTo>
                  <a:lnTo>
                    <a:pt x="515" y="1028"/>
                  </a:lnTo>
                  <a:close/>
                  <a:moveTo>
                    <a:pt x="1035" y="737"/>
                  </a:moveTo>
                  <a:lnTo>
                    <a:pt x="1241" y="737"/>
                  </a:lnTo>
                  <a:lnTo>
                    <a:pt x="1241" y="1548"/>
                  </a:lnTo>
                  <a:lnTo>
                    <a:pt x="1035" y="1548"/>
                  </a:lnTo>
                  <a:lnTo>
                    <a:pt x="1035" y="737"/>
                  </a:lnTo>
                  <a:close/>
                  <a:moveTo>
                    <a:pt x="1556" y="554"/>
                  </a:moveTo>
                  <a:lnTo>
                    <a:pt x="1761" y="554"/>
                  </a:lnTo>
                  <a:lnTo>
                    <a:pt x="1761" y="1548"/>
                  </a:lnTo>
                  <a:lnTo>
                    <a:pt x="1556" y="1548"/>
                  </a:lnTo>
                  <a:lnTo>
                    <a:pt x="1556" y="554"/>
                  </a:lnTo>
                  <a:close/>
                  <a:moveTo>
                    <a:pt x="2076" y="12"/>
                  </a:moveTo>
                  <a:lnTo>
                    <a:pt x="2282" y="12"/>
                  </a:lnTo>
                  <a:lnTo>
                    <a:pt x="2282" y="1548"/>
                  </a:lnTo>
                  <a:lnTo>
                    <a:pt x="2076" y="1548"/>
                  </a:lnTo>
                  <a:lnTo>
                    <a:pt x="2076" y="12"/>
                  </a:lnTo>
                  <a:close/>
                  <a:moveTo>
                    <a:pt x="2591" y="0"/>
                  </a:moveTo>
                  <a:lnTo>
                    <a:pt x="2803" y="0"/>
                  </a:lnTo>
                  <a:lnTo>
                    <a:pt x="2803" y="1548"/>
                  </a:lnTo>
                  <a:lnTo>
                    <a:pt x="2591" y="1548"/>
                  </a:lnTo>
                  <a:lnTo>
                    <a:pt x="2591" y="0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" name="Freeform 7"/>
            <p:cNvSpPr>
              <a:spLocks noEditPoints="1"/>
            </p:cNvSpPr>
            <p:nvPr/>
          </p:nvSpPr>
          <p:spPr bwMode="auto">
            <a:xfrm>
              <a:off x="4257676" y="2317751"/>
              <a:ext cx="4449763" cy="2457450"/>
            </a:xfrm>
            <a:custGeom>
              <a:avLst/>
              <a:gdLst>
                <a:gd name="T0" fmla="*/ 0 w 2803"/>
                <a:gd name="T1" fmla="*/ 1280 h 1548"/>
                <a:gd name="T2" fmla="*/ 206 w 2803"/>
                <a:gd name="T3" fmla="*/ 1280 h 1548"/>
                <a:gd name="T4" fmla="*/ 206 w 2803"/>
                <a:gd name="T5" fmla="*/ 1548 h 1548"/>
                <a:gd name="T6" fmla="*/ 0 w 2803"/>
                <a:gd name="T7" fmla="*/ 1548 h 1548"/>
                <a:gd name="T8" fmla="*/ 0 w 2803"/>
                <a:gd name="T9" fmla="*/ 1280 h 1548"/>
                <a:gd name="T10" fmla="*/ 515 w 2803"/>
                <a:gd name="T11" fmla="*/ 1028 h 1548"/>
                <a:gd name="T12" fmla="*/ 726 w 2803"/>
                <a:gd name="T13" fmla="*/ 1028 h 1548"/>
                <a:gd name="T14" fmla="*/ 726 w 2803"/>
                <a:gd name="T15" fmla="*/ 1548 h 1548"/>
                <a:gd name="T16" fmla="*/ 515 w 2803"/>
                <a:gd name="T17" fmla="*/ 1548 h 1548"/>
                <a:gd name="T18" fmla="*/ 515 w 2803"/>
                <a:gd name="T19" fmla="*/ 1028 h 1548"/>
                <a:gd name="T20" fmla="*/ 1035 w 2803"/>
                <a:gd name="T21" fmla="*/ 737 h 1548"/>
                <a:gd name="T22" fmla="*/ 1241 w 2803"/>
                <a:gd name="T23" fmla="*/ 737 h 1548"/>
                <a:gd name="T24" fmla="*/ 1241 w 2803"/>
                <a:gd name="T25" fmla="*/ 1548 h 1548"/>
                <a:gd name="T26" fmla="*/ 1035 w 2803"/>
                <a:gd name="T27" fmla="*/ 1548 h 1548"/>
                <a:gd name="T28" fmla="*/ 1035 w 2803"/>
                <a:gd name="T29" fmla="*/ 737 h 1548"/>
                <a:gd name="T30" fmla="*/ 1556 w 2803"/>
                <a:gd name="T31" fmla="*/ 554 h 1548"/>
                <a:gd name="T32" fmla="*/ 1761 w 2803"/>
                <a:gd name="T33" fmla="*/ 554 h 1548"/>
                <a:gd name="T34" fmla="*/ 1761 w 2803"/>
                <a:gd name="T35" fmla="*/ 1548 h 1548"/>
                <a:gd name="T36" fmla="*/ 1556 w 2803"/>
                <a:gd name="T37" fmla="*/ 1548 h 1548"/>
                <a:gd name="T38" fmla="*/ 1556 w 2803"/>
                <a:gd name="T39" fmla="*/ 554 h 1548"/>
                <a:gd name="T40" fmla="*/ 2076 w 2803"/>
                <a:gd name="T41" fmla="*/ 12 h 1548"/>
                <a:gd name="T42" fmla="*/ 2282 w 2803"/>
                <a:gd name="T43" fmla="*/ 12 h 1548"/>
                <a:gd name="T44" fmla="*/ 2282 w 2803"/>
                <a:gd name="T45" fmla="*/ 1548 h 1548"/>
                <a:gd name="T46" fmla="*/ 2076 w 2803"/>
                <a:gd name="T47" fmla="*/ 1548 h 1548"/>
                <a:gd name="T48" fmla="*/ 2076 w 2803"/>
                <a:gd name="T49" fmla="*/ 12 h 1548"/>
                <a:gd name="T50" fmla="*/ 2591 w 2803"/>
                <a:gd name="T51" fmla="*/ 0 h 1548"/>
                <a:gd name="T52" fmla="*/ 2803 w 2803"/>
                <a:gd name="T53" fmla="*/ 0 h 1548"/>
                <a:gd name="T54" fmla="*/ 2803 w 2803"/>
                <a:gd name="T55" fmla="*/ 1548 h 1548"/>
                <a:gd name="T56" fmla="*/ 2591 w 2803"/>
                <a:gd name="T57" fmla="*/ 1548 h 1548"/>
                <a:gd name="T58" fmla="*/ 2591 w 2803"/>
                <a:gd name="T59" fmla="*/ 0 h 15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803" h="1548">
                  <a:moveTo>
                    <a:pt x="0" y="1280"/>
                  </a:moveTo>
                  <a:lnTo>
                    <a:pt x="206" y="1280"/>
                  </a:lnTo>
                  <a:lnTo>
                    <a:pt x="206" y="1548"/>
                  </a:lnTo>
                  <a:lnTo>
                    <a:pt x="0" y="1548"/>
                  </a:lnTo>
                  <a:lnTo>
                    <a:pt x="0" y="1280"/>
                  </a:lnTo>
                  <a:close/>
                  <a:moveTo>
                    <a:pt x="515" y="1028"/>
                  </a:moveTo>
                  <a:lnTo>
                    <a:pt x="726" y="1028"/>
                  </a:lnTo>
                  <a:lnTo>
                    <a:pt x="726" y="1548"/>
                  </a:lnTo>
                  <a:lnTo>
                    <a:pt x="515" y="1548"/>
                  </a:lnTo>
                  <a:lnTo>
                    <a:pt x="515" y="1028"/>
                  </a:lnTo>
                  <a:close/>
                  <a:moveTo>
                    <a:pt x="1035" y="737"/>
                  </a:moveTo>
                  <a:lnTo>
                    <a:pt x="1241" y="737"/>
                  </a:lnTo>
                  <a:lnTo>
                    <a:pt x="1241" y="1548"/>
                  </a:lnTo>
                  <a:lnTo>
                    <a:pt x="1035" y="1548"/>
                  </a:lnTo>
                  <a:lnTo>
                    <a:pt x="1035" y="737"/>
                  </a:lnTo>
                  <a:close/>
                  <a:moveTo>
                    <a:pt x="1556" y="554"/>
                  </a:moveTo>
                  <a:lnTo>
                    <a:pt x="1761" y="554"/>
                  </a:lnTo>
                  <a:lnTo>
                    <a:pt x="1761" y="1548"/>
                  </a:lnTo>
                  <a:lnTo>
                    <a:pt x="1556" y="1548"/>
                  </a:lnTo>
                  <a:lnTo>
                    <a:pt x="1556" y="554"/>
                  </a:lnTo>
                  <a:close/>
                  <a:moveTo>
                    <a:pt x="2076" y="12"/>
                  </a:moveTo>
                  <a:lnTo>
                    <a:pt x="2282" y="12"/>
                  </a:lnTo>
                  <a:lnTo>
                    <a:pt x="2282" y="1548"/>
                  </a:lnTo>
                  <a:lnTo>
                    <a:pt x="2076" y="1548"/>
                  </a:lnTo>
                  <a:lnTo>
                    <a:pt x="2076" y="12"/>
                  </a:lnTo>
                  <a:close/>
                  <a:moveTo>
                    <a:pt x="2591" y="0"/>
                  </a:moveTo>
                  <a:lnTo>
                    <a:pt x="2803" y="0"/>
                  </a:lnTo>
                  <a:lnTo>
                    <a:pt x="2803" y="1548"/>
                  </a:lnTo>
                  <a:lnTo>
                    <a:pt x="2591" y="1548"/>
                  </a:lnTo>
                  <a:lnTo>
                    <a:pt x="2591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Freeform 8"/>
            <p:cNvSpPr>
              <a:spLocks noEditPoints="1"/>
            </p:cNvSpPr>
            <p:nvPr/>
          </p:nvSpPr>
          <p:spPr bwMode="auto">
            <a:xfrm flipV="1">
              <a:off x="4394201" y="4308694"/>
              <a:ext cx="45719" cy="85316"/>
            </a:xfrm>
            <a:custGeom>
              <a:avLst/>
              <a:gdLst>
                <a:gd name="T0" fmla="*/ 17 w 34"/>
                <a:gd name="T1" fmla="*/ 6 h 12"/>
                <a:gd name="T2" fmla="*/ 17 w 34"/>
                <a:gd name="T3" fmla="*/ 12 h 12"/>
                <a:gd name="T4" fmla="*/ 17 w 34"/>
                <a:gd name="T5" fmla="*/ 6 h 12"/>
                <a:gd name="T6" fmla="*/ 17 w 34"/>
                <a:gd name="T7" fmla="*/ 0 h 12"/>
                <a:gd name="T8" fmla="*/ 0 w 34"/>
                <a:gd name="T9" fmla="*/ 12 h 12"/>
                <a:gd name="T10" fmla="*/ 34 w 34"/>
                <a:gd name="T11" fmla="*/ 12 h 12"/>
                <a:gd name="T12" fmla="*/ 0 w 34"/>
                <a:gd name="T13" fmla="*/ 0 h 12"/>
                <a:gd name="T14" fmla="*/ 34 w 34"/>
                <a:gd name="T15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12">
                  <a:moveTo>
                    <a:pt x="17" y="6"/>
                  </a:moveTo>
                  <a:lnTo>
                    <a:pt x="17" y="12"/>
                  </a:lnTo>
                  <a:moveTo>
                    <a:pt x="17" y="6"/>
                  </a:moveTo>
                  <a:lnTo>
                    <a:pt x="17" y="0"/>
                  </a:lnTo>
                  <a:moveTo>
                    <a:pt x="0" y="12"/>
                  </a:moveTo>
                  <a:lnTo>
                    <a:pt x="34" y="12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" name="Freeform 9"/>
            <p:cNvSpPr>
              <a:spLocks noEditPoints="1"/>
            </p:cNvSpPr>
            <p:nvPr/>
          </p:nvSpPr>
          <p:spPr bwMode="auto">
            <a:xfrm>
              <a:off x="5219701" y="3905251"/>
              <a:ext cx="53975" cy="80963"/>
            </a:xfrm>
            <a:custGeom>
              <a:avLst/>
              <a:gdLst>
                <a:gd name="T0" fmla="*/ 17 w 34"/>
                <a:gd name="T1" fmla="*/ 28 h 51"/>
                <a:gd name="T2" fmla="*/ 17 w 34"/>
                <a:gd name="T3" fmla="*/ 51 h 51"/>
                <a:gd name="T4" fmla="*/ 17 w 34"/>
                <a:gd name="T5" fmla="*/ 28 h 51"/>
                <a:gd name="T6" fmla="*/ 17 w 34"/>
                <a:gd name="T7" fmla="*/ 0 h 51"/>
                <a:gd name="T8" fmla="*/ 0 w 34"/>
                <a:gd name="T9" fmla="*/ 51 h 51"/>
                <a:gd name="T10" fmla="*/ 34 w 34"/>
                <a:gd name="T11" fmla="*/ 51 h 51"/>
                <a:gd name="T12" fmla="*/ 0 w 34"/>
                <a:gd name="T13" fmla="*/ 0 h 51"/>
                <a:gd name="T14" fmla="*/ 34 w 34"/>
                <a:gd name="T15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51">
                  <a:moveTo>
                    <a:pt x="17" y="28"/>
                  </a:moveTo>
                  <a:lnTo>
                    <a:pt x="17" y="51"/>
                  </a:lnTo>
                  <a:moveTo>
                    <a:pt x="17" y="28"/>
                  </a:moveTo>
                  <a:lnTo>
                    <a:pt x="17" y="0"/>
                  </a:lnTo>
                  <a:moveTo>
                    <a:pt x="0" y="51"/>
                  </a:moveTo>
                  <a:lnTo>
                    <a:pt x="34" y="51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" name="Freeform 10"/>
            <p:cNvSpPr>
              <a:spLocks noEditPoints="1"/>
            </p:cNvSpPr>
            <p:nvPr/>
          </p:nvSpPr>
          <p:spPr bwMode="auto">
            <a:xfrm>
              <a:off x="6037263" y="3406776"/>
              <a:ext cx="53975" cy="163513"/>
            </a:xfrm>
            <a:custGeom>
              <a:avLst/>
              <a:gdLst>
                <a:gd name="T0" fmla="*/ 17 w 34"/>
                <a:gd name="T1" fmla="*/ 51 h 103"/>
                <a:gd name="T2" fmla="*/ 17 w 34"/>
                <a:gd name="T3" fmla="*/ 103 h 103"/>
                <a:gd name="T4" fmla="*/ 17 w 34"/>
                <a:gd name="T5" fmla="*/ 51 h 103"/>
                <a:gd name="T6" fmla="*/ 17 w 34"/>
                <a:gd name="T7" fmla="*/ 0 h 103"/>
                <a:gd name="T8" fmla="*/ 0 w 34"/>
                <a:gd name="T9" fmla="*/ 103 h 103"/>
                <a:gd name="T10" fmla="*/ 34 w 34"/>
                <a:gd name="T11" fmla="*/ 103 h 103"/>
                <a:gd name="T12" fmla="*/ 0 w 34"/>
                <a:gd name="T13" fmla="*/ 0 h 103"/>
                <a:gd name="T14" fmla="*/ 34 w 34"/>
                <a:gd name="T15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103">
                  <a:moveTo>
                    <a:pt x="17" y="51"/>
                  </a:moveTo>
                  <a:lnTo>
                    <a:pt x="17" y="103"/>
                  </a:lnTo>
                  <a:moveTo>
                    <a:pt x="17" y="51"/>
                  </a:moveTo>
                  <a:lnTo>
                    <a:pt x="17" y="0"/>
                  </a:lnTo>
                  <a:moveTo>
                    <a:pt x="0" y="103"/>
                  </a:moveTo>
                  <a:lnTo>
                    <a:pt x="34" y="103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" name="Freeform 11"/>
            <p:cNvSpPr>
              <a:spLocks noEditPoints="1"/>
            </p:cNvSpPr>
            <p:nvPr/>
          </p:nvSpPr>
          <p:spPr bwMode="auto">
            <a:xfrm>
              <a:off x="6862763" y="2943226"/>
              <a:ext cx="55563" cy="500063"/>
            </a:xfrm>
            <a:custGeom>
              <a:avLst/>
              <a:gdLst>
                <a:gd name="T0" fmla="*/ 18 w 35"/>
                <a:gd name="T1" fmla="*/ 160 h 315"/>
                <a:gd name="T2" fmla="*/ 18 w 35"/>
                <a:gd name="T3" fmla="*/ 315 h 315"/>
                <a:gd name="T4" fmla="*/ 18 w 35"/>
                <a:gd name="T5" fmla="*/ 160 h 315"/>
                <a:gd name="T6" fmla="*/ 18 w 35"/>
                <a:gd name="T7" fmla="*/ 0 h 315"/>
                <a:gd name="T8" fmla="*/ 0 w 35"/>
                <a:gd name="T9" fmla="*/ 315 h 315"/>
                <a:gd name="T10" fmla="*/ 35 w 35"/>
                <a:gd name="T11" fmla="*/ 315 h 315"/>
                <a:gd name="T12" fmla="*/ 0 w 35"/>
                <a:gd name="T13" fmla="*/ 0 h 315"/>
                <a:gd name="T14" fmla="*/ 35 w 35"/>
                <a:gd name="T15" fmla="*/ 0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315">
                  <a:moveTo>
                    <a:pt x="18" y="160"/>
                  </a:moveTo>
                  <a:lnTo>
                    <a:pt x="18" y="315"/>
                  </a:lnTo>
                  <a:moveTo>
                    <a:pt x="18" y="160"/>
                  </a:moveTo>
                  <a:lnTo>
                    <a:pt x="18" y="0"/>
                  </a:lnTo>
                  <a:moveTo>
                    <a:pt x="0" y="315"/>
                  </a:moveTo>
                  <a:lnTo>
                    <a:pt x="35" y="315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" name="Freeform 12"/>
            <p:cNvSpPr>
              <a:spLocks noEditPoints="1"/>
            </p:cNvSpPr>
            <p:nvPr/>
          </p:nvSpPr>
          <p:spPr bwMode="auto">
            <a:xfrm>
              <a:off x="7689851" y="1982788"/>
              <a:ext cx="53975" cy="706438"/>
            </a:xfrm>
            <a:custGeom>
              <a:avLst/>
              <a:gdLst>
                <a:gd name="T0" fmla="*/ 17 w 34"/>
                <a:gd name="T1" fmla="*/ 223 h 445"/>
                <a:gd name="T2" fmla="*/ 17 w 34"/>
                <a:gd name="T3" fmla="*/ 445 h 445"/>
                <a:gd name="T4" fmla="*/ 17 w 34"/>
                <a:gd name="T5" fmla="*/ 223 h 445"/>
                <a:gd name="T6" fmla="*/ 17 w 34"/>
                <a:gd name="T7" fmla="*/ 0 h 445"/>
                <a:gd name="T8" fmla="*/ 0 w 34"/>
                <a:gd name="T9" fmla="*/ 445 h 445"/>
                <a:gd name="T10" fmla="*/ 34 w 34"/>
                <a:gd name="T11" fmla="*/ 445 h 445"/>
                <a:gd name="T12" fmla="*/ 0 w 34"/>
                <a:gd name="T13" fmla="*/ 0 h 445"/>
                <a:gd name="T14" fmla="*/ 34 w 34"/>
                <a:gd name="T15" fmla="*/ 0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445">
                  <a:moveTo>
                    <a:pt x="17" y="223"/>
                  </a:moveTo>
                  <a:lnTo>
                    <a:pt x="17" y="445"/>
                  </a:lnTo>
                  <a:moveTo>
                    <a:pt x="17" y="223"/>
                  </a:moveTo>
                  <a:lnTo>
                    <a:pt x="17" y="0"/>
                  </a:lnTo>
                  <a:moveTo>
                    <a:pt x="0" y="445"/>
                  </a:moveTo>
                  <a:lnTo>
                    <a:pt x="34" y="445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" name="Freeform 13"/>
            <p:cNvSpPr>
              <a:spLocks noEditPoints="1"/>
            </p:cNvSpPr>
            <p:nvPr/>
          </p:nvSpPr>
          <p:spPr bwMode="auto">
            <a:xfrm>
              <a:off x="8507413" y="2090738"/>
              <a:ext cx="53975" cy="454025"/>
            </a:xfrm>
            <a:custGeom>
              <a:avLst/>
              <a:gdLst>
                <a:gd name="T0" fmla="*/ 17 w 34"/>
                <a:gd name="T1" fmla="*/ 143 h 286"/>
                <a:gd name="T2" fmla="*/ 17 w 34"/>
                <a:gd name="T3" fmla="*/ 286 h 286"/>
                <a:gd name="T4" fmla="*/ 17 w 34"/>
                <a:gd name="T5" fmla="*/ 143 h 286"/>
                <a:gd name="T6" fmla="*/ 17 w 34"/>
                <a:gd name="T7" fmla="*/ 0 h 286"/>
                <a:gd name="T8" fmla="*/ 0 w 34"/>
                <a:gd name="T9" fmla="*/ 286 h 286"/>
                <a:gd name="T10" fmla="*/ 34 w 34"/>
                <a:gd name="T11" fmla="*/ 286 h 286"/>
                <a:gd name="T12" fmla="*/ 0 w 34"/>
                <a:gd name="T13" fmla="*/ 0 h 286"/>
                <a:gd name="T14" fmla="*/ 34 w 34"/>
                <a:gd name="T15" fmla="*/ 0 h 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286">
                  <a:moveTo>
                    <a:pt x="17" y="143"/>
                  </a:moveTo>
                  <a:lnTo>
                    <a:pt x="17" y="286"/>
                  </a:lnTo>
                  <a:moveTo>
                    <a:pt x="17" y="143"/>
                  </a:moveTo>
                  <a:lnTo>
                    <a:pt x="17" y="0"/>
                  </a:lnTo>
                  <a:moveTo>
                    <a:pt x="0" y="286"/>
                  </a:moveTo>
                  <a:lnTo>
                    <a:pt x="34" y="286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5" name="Line 14"/>
            <p:cNvSpPr>
              <a:spLocks noChangeShapeType="1"/>
            </p:cNvSpPr>
            <p:nvPr/>
          </p:nvSpPr>
          <p:spPr bwMode="auto">
            <a:xfrm flipV="1">
              <a:off x="4003676" y="1619251"/>
              <a:ext cx="0" cy="315595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Line 15"/>
            <p:cNvSpPr>
              <a:spLocks noChangeShapeType="1"/>
            </p:cNvSpPr>
            <p:nvPr/>
          </p:nvSpPr>
          <p:spPr bwMode="auto">
            <a:xfrm>
              <a:off x="4003676" y="4775201"/>
              <a:ext cx="49482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3771901" y="4676776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de-DE" altLang="de-DE" sz="14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3630613" y="4151313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3630613" y="3625851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3630613" y="3101976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3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20"/>
            <p:cNvSpPr>
              <a:spLocks noChangeArrowheads="1"/>
            </p:cNvSpPr>
            <p:nvPr/>
          </p:nvSpPr>
          <p:spPr bwMode="auto">
            <a:xfrm>
              <a:off x="3630613" y="2576513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3630613" y="2051051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5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Rectangle 22"/>
            <p:cNvSpPr>
              <a:spLocks noChangeArrowheads="1"/>
            </p:cNvSpPr>
            <p:nvPr/>
          </p:nvSpPr>
          <p:spPr bwMode="auto">
            <a:xfrm>
              <a:off x="3630613" y="1524001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de-DE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" name="Rectangle 23"/>
            <p:cNvSpPr>
              <a:spLocks noChangeArrowheads="1"/>
            </p:cNvSpPr>
            <p:nvPr/>
          </p:nvSpPr>
          <p:spPr bwMode="auto">
            <a:xfrm>
              <a:off x="4329113" y="487838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de-DE" alt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24"/>
            <p:cNvSpPr>
              <a:spLocks noChangeArrowheads="1"/>
            </p:cNvSpPr>
            <p:nvPr/>
          </p:nvSpPr>
          <p:spPr bwMode="auto">
            <a:xfrm>
              <a:off x="5153026" y="487838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de-DE" alt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5"/>
            <p:cNvSpPr>
              <a:spLocks noChangeArrowheads="1"/>
            </p:cNvSpPr>
            <p:nvPr/>
          </p:nvSpPr>
          <p:spPr bwMode="auto">
            <a:xfrm>
              <a:off x="5976938" y="487838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de-DE" alt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6800851" y="487838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de-DE" alt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Rectangle 27"/>
            <p:cNvSpPr>
              <a:spLocks noChangeArrowheads="1"/>
            </p:cNvSpPr>
            <p:nvPr/>
          </p:nvSpPr>
          <p:spPr bwMode="auto">
            <a:xfrm>
              <a:off x="7577138" y="4878388"/>
              <a:ext cx="2882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0</a:t>
              </a:r>
              <a:endParaRPr kumimoji="0" lang="de-DE" alt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8401051" y="487838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40</a:t>
              </a:r>
              <a:endParaRPr kumimoji="0" lang="de-DE" alt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 rot="16200000" flipH="1">
              <a:off x="2044720" y="2962931"/>
              <a:ext cx="25923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inal </a:t>
              </a:r>
              <a:r>
                <a:rPr kumimoji="0" lang="de-DE" altLang="de-DE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ptical</a:t>
              </a:r>
              <a:r>
                <a:rPr kumimoji="0" lang="de-DE" altLang="de-DE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nsity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5959476" y="5127626"/>
              <a:ext cx="11429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OH</a:t>
              </a:r>
              <a:r>
                <a:rPr kumimoji="0" lang="de-DE" altLang="de-DE" sz="1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(</a:t>
              </a:r>
              <a:r>
                <a:rPr kumimoji="0" lang="de-DE" altLang="de-DE" sz="16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M</a:t>
              </a:r>
              <a:r>
                <a:rPr kumimoji="0" lang="de-DE" altLang="de-DE" sz="1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de-DE" altLang="de-DE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Line 15"/>
            <p:cNvSpPr>
              <a:spLocks noChangeShapeType="1"/>
            </p:cNvSpPr>
            <p:nvPr/>
          </p:nvSpPr>
          <p:spPr bwMode="auto">
            <a:xfrm>
              <a:off x="4003676" y="1619848"/>
              <a:ext cx="49482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Line 14"/>
            <p:cNvSpPr>
              <a:spLocks noChangeShapeType="1"/>
            </p:cNvSpPr>
            <p:nvPr/>
          </p:nvSpPr>
          <p:spPr bwMode="auto">
            <a:xfrm flipV="1">
              <a:off x="8951626" y="1619251"/>
              <a:ext cx="0" cy="315595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Textfeld 33"/>
          <p:cNvSpPr txBox="1"/>
          <p:nvPr/>
        </p:nvSpPr>
        <p:spPr>
          <a:xfrm>
            <a:off x="2144986" y="5537453"/>
            <a:ext cx="82461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1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ependence of methanol concentration and final optical density 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627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1"/>
          <p:cNvSpPr>
            <a:spLocks noChangeArrowheads="1"/>
          </p:cNvSpPr>
          <p:nvPr/>
        </p:nvSpPr>
        <p:spPr bwMode="auto">
          <a:xfrm>
            <a:off x="3692208" y="3671752"/>
            <a:ext cx="112713" cy="111125"/>
          </a:xfrm>
          <a:prstGeom prst="ellipse">
            <a:avLst/>
          </a:prstGeom>
          <a:noFill/>
          <a:ln w="14288" cap="flat">
            <a:solidFill>
              <a:schemeClr val="bg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" name="Line 8"/>
          <p:cNvSpPr>
            <a:spLocks noChangeShapeType="1"/>
          </p:cNvSpPr>
          <p:nvPr/>
        </p:nvSpPr>
        <p:spPr bwMode="auto">
          <a:xfrm flipV="1">
            <a:off x="3636970" y="850447"/>
            <a:ext cx="0" cy="2917825"/>
          </a:xfrm>
          <a:prstGeom prst="line">
            <a:avLst/>
          </a:prstGeom>
          <a:noFill/>
          <a:ln w="14288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Line 9"/>
          <p:cNvSpPr>
            <a:spLocks noChangeShapeType="1"/>
          </p:cNvSpPr>
          <p:nvPr/>
        </p:nvSpPr>
        <p:spPr bwMode="auto">
          <a:xfrm>
            <a:off x="3658236" y="3768272"/>
            <a:ext cx="5319713" cy="0"/>
          </a:xfrm>
          <a:prstGeom prst="line">
            <a:avLst/>
          </a:prstGeom>
          <a:noFill/>
          <a:ln w="14288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5" name="Oval 16"/>
          <p:cNvSpPr>
            <a:spLocks noChangeArrowheads="1"/>
          </p:cNvSpPr>
          <p:nvPr/>
        </p:nvSpPr>
        <p:spPr bwMode="auto">
          <a:xfrm>
            <a:off x="4253548" y="3066597"/>
            <a:ext cx="112713" cy="112713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6" name="Oval 17"/>
          <p:cNvSpPr>
            <a:spLocks noChangeArrowheads="1"/>
          </p:cNvSpPr>
          <p:nvPr/>
        </p:nvSpPr>
        <p:spPr bwMode="auto">
          <a:xfrm>
            <a:off x="4253548" y="3066597"/>
            <a:ext cx="112713" cy="112713"/>
          </a:xfrm>
          <a:prstGeom prst="ellipse">
            <a:avLst/>
          </a:pr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grpSp>
        <p:nvGrpSpPr>
          <p:cNvPr id="7" name="Gruppieren 6"/>
          <p:cNvGrpSpPr/>
          <p:nvPr/>
        </p:nvGrpSpPr>
        <p:grpSpPr>
          <a:xfrm>
            <a:off x="5261611" y="2561772"/>
            <a:ext cx="111125" cy="112713"/>
            <a:chOff x="5261611" y="2561772"/>
            <a:chExt cx="111125" cy="112713"/>
          </a:xfrm>
        </p:grpSpPr>
        <p:sp>
          <p:nvSpPr>
            <p:cNvPr id="8" name="Oval 18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Oval 19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grpSp>
        <p:nvGrpSpPr>
          <p:cNvPr id="10" name="Gruppieren 9"/>
          <p:cNvGrpSpPr/>
          <p:nvPr/>
        </p:nvGrpSpPr>
        <p:grpSpPr>
          <a:xfrm>
            <a:off x="5988686" y="2576059"/>
            <a:ext cx="112713" cy="111125"/>
            <a:chOff x="5622926" y="3925888"/>
            <a:chExt cx="112713" cy="111125"/>
          </a:xfrm>
        </p:grpSpPr>
        <p:sp>
          <p:nvSpPr>
            <p:cNvPr id="11" name="Oval 20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" name="Oval 21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sp>
        <p:nvSpPr>
          <p:cNvPr id="13" name="Oval 22"/>
          <p:cNvSpPr>
            <a:spLocks noChangeArrowheads="1"/>
          </p:cNvSpPr>
          <p:nvPr/>
        </p:nvSpPr>
        <p:spPr bwMode="auto">
          <a:xfrm>
            <a:off x="6815773" y="2169659"/>
            <a:ext cx="111125" cy="111125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4" name="Oval 23"/>
          <p:cNvSpPr>
            <a:spLocks noChangeArrowheads="1"/>
          </p:cNvSpPr>
          <p:nvPr/>
        </p:nvSpPr>
        <p:spPr bwMode="auto">
          <a:xfrm>
            <a:off x="6815773" y="2169659"/>
            <a:ext cx="111125" cy="111125"/>
          </a:xfrm>
          <a:prstGeom prst="ellipse">
            <a:avLst/>
          </a:pr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5" name="Oval 28"/>
          <p:cNvSpPr>
            <a:spLocks noChangeArrowheads="1"/>
          </p:cNvSpPr>
          <p:nvPr/>
        </p:nvSpPr>
        <p:spPr bwMode="auto">
          <a:xfrm>
            <a:off x="8312786" y="1410834"/>
            <a:ext cx="112713" cy="112713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6" name="Oval 29"/>
          <p:cNvSpPr>
            <a:spLocks noChangeArrowheads="1"/>
          </p:cNvSpPr>
          <p:nvPr/>
        </p:nvSpPr>
        <p:spPr bwMode="auto">
          <a:xfrm>
            <a:off x="8312786" y="1410834"/>
            <a:ext cx="112713" cy="112713"/>
          </a:xfrm>
          <a:prstGeom prst="ellipse">
            <a:avLst/>
          </a:pr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7" name="Rectangle 31"/>
          <p:cNvSpPr>
            <a:spLocks noChangeArrowheads="1"/>
          </p:cNvSpPr>
          <p:nvPr/>
        </p:nvSpPr>
        <p:spPr bwMode="auto">
          <a:xfrm>
            <a:off x="6037898" y="1172709"/>
            <a:ext cx="68929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3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</a:rPr>
              <a:t>y = 16.48x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</a:endParaRPr>
          </a:p>
        </p:txBody>
      </p:sp>
      <p:sp>
        <p:nvSpPr>
          <p:cNvPr id="18" name="Rectangle 32"/>
          <p:cNvSpPr>
            <a:spLocks noChangeArrowheads="1"/>
          </p:cNvSpPr>
          <p:nvPr/>
        </p:nvSpPr>
        <p:spPr bwMode="auto">
          <a:xfrm>
            <a:off x="6037898" y="1385434"/>
            <a:ext cx="68768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3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</a:rPr>
              <a:t>R² = 0,923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</a:endParaRPr>
          </a:p>
        </p:txBody>
      </p:sp>
      <p:sp>
        <p:nvSpPr>
          <p:cNvPr id="19" name="Rectangle 33"/>
          <p:cNvSpPr>
            <a:spLocks noChangeArrowheads="1"/>
          </p:cNvSpPr>
          <p:nvPr/>
        </p:nvSpPr>
        <p:spPr bwMode="auto">
          <a:xfrm>
            <a:off x="3402020" y="3657147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" name="Rectangle 34"/>
          <p:cNvSpPr>
            <a:spLocks noChangeArrowheads="1"/>
          </p:cNvSpPr>
          <p:nvPr/>
        </p:nvSpPr>
        <p:spPr bwMode="auto">
          <a:xfrm>
            <a:off x="3402020" y="3169784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" name="Rectangle 35"/>
          <p:cNvSpPr>
            <a:spLocks noChangeArrowheads="1"/>
          </p:cNvSpPr>
          <p:nvPr/>
        </p:nvSpPr>
        <p:spPr bwMode="auto">
          <a:xfrm>
            <a:off x="3402020" y="2687184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" name="Rectangle 36"/>
          <p:cNvSpPr>
            <a:spLocks noChangeArrowheads="1"/>
          </p:cNvSpPr>
          <p:nvPr/>
        </p:nvSpPr>
        <p:spPr bwMode="auto">
          <a:xfrm>
            <a:off x="3402020" y="2201409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3</a:t>
            </a:r>
          </a:p>
        </p:txBody>
      </p:sp>
      <p:sp>
        <p:nvSpPr>
          <p:cNvPr id="23" name="Rectangle 37"/>
          <p:cNvSpPr>
            <a:spLocks noChangeArrowheads="1"/>
          </p:cNvSpPr>
          <p:nvPr/>
        </p:nvSpPr>
        <p:spPr bwMode="auto">
          <a:xfrm>
            <a:off x="3402020" y="1715634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4</a:t>
            </a:r>
          </a:p>
        </p:txBody>
      </p:sp>
      <p:sp>
        <p:nvSpPr>
          <p:cNvPr id="24" name="Rectangle 38"/>
          <p:cNvSpPr>
            <a:spLocks noChangeArrowheads="1"/>
          </p:cNvSpPr>
          <p:nvPr/>
        </p:nvSpPr>
        <p:spPr bwMode="auto">
          <a:xfrm>
            <a:off x="3402020" y="1228272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5</a:t>
            </a:r>
          </a:p>
        </p:txBody>
      </p:sp>
      <p:sp>
        <p:nvSpPr>
          <p:cNvPr id="25" name="Rectangle 39"/>
          <p:cNvSpPr>
            <a:spLocks noChangeArrowheads="1"/>
          </p:cNvSpPr>
          <p:nvPr/>
        </p:nvSpPr>
        <p:spPr bwMode="auto">
          <a:xfrm>
            <a:off x="3402020" y="745672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6</a:t>
            </a:r>
          </a:p>
        </p:txBody>
      </p:sp>
      <p:sp>
        <p:nvSpPr>
          <p:cNvPr id="26" name="Rectangle 40"/>
          <p:cNvSpPr>
            <a:spLocks noChangeArrowheads="1"/>
          </p:cNvSpPr>
          <p:nvPr/>
        </p:nvSpPr>
        <p:spPr bwMode="auto">
          <a:xfrm>
            <a:off x="3621723" y="3876222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27" name="Rectangle 41"/>
          <p:cNvSpPr>
            <a:spLocks noChangeArrowheads="1"/>
          </p:cNvSpPr>
          <p:nvPr/>
        </p:nvSpPr>
        <p:spPr bwMode="auto">
          <a:xfrm>
            <a:off x="4402773" y="3876222"/>
            <a:ext cx="3478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28" name="Rectangle 42"/>
          <p:cNvSpPr>
            <a:spLocks noChangeArrowheads="1"/>
          </p:cNvSpPr>
          <p:nvPr/>
        </p:nvSpPr>
        <p:spPr bwMode="auto">
          <a:xfrm>
            <a:off x="5333048" y="3876222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9" name="Rectangle 43"/>
          <p:cNvSpPr>
            <a:spLocks noChangeArrowheads="1"/>
          </p:cNvSpPr>
          <p:nvPr/>
        </p:nvSpPr>
        <p:spPr bwMode="auto">
          <a:xfrm>
            <a:off x="6177598" y="3876222"/>
            <a:ext cx="3478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30" name="Rectangle 44"/>
          <p:cNvSpPr>
            <a:spLocks noChangeArrowheads="1"/>
          </p:cNvSpPr>
          <p:nvPr/>
        </p:nvSpPr>
        <p:spPr bwMode="auto">
          <a:xfrm>
            <a:off x="7107873" y="3876222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31" name="Rectangle 45"/>
          <p:cNvSpPr>
            <a:spLocks noChangeArrowheads="1"/>
          </p:cNvSpPr>
          <p:nvPr/>
        </p:nvSpPr>
        <p:spPr bwMode="auto">
          <a:xfrm>
            <a:off x="7952423" y="3876222"/>
            <a:ext cx="3478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32" name="Rectangle 46"/>
          <p:cNvSpPr>
            <a:spLocks noChangeArrowheads="1"/>
          </p:cNvSpPr>
          <p:nvPr/>
        </p:nvSpPr>
        <p:spPr bwMode="auto">
          <a:xfrm>
            <a:off x="8882698" y="3876222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33" name="Rectangle 48"/>
          <p:cNvSpPr>
            <a:spLocks noChangeArrowheads="1"/>
          </p:cNvSpPr>
          <p:nvPr/>
        </p:nvSpPr>
        <p:spPr bwMode="auto">
          <a:xfrm>
            <a:off x="2779352" y="510869"/>
            <a:ext cx="6506572" cy="4051004"/>
          </a:xfrm>
          <a:prstGeom prst="rect">
            <a:avLst/>
          </a:prstGeom>
          <a:noFill/>
          <a:ln w="14288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4" name="Textfeld 33"/>
          <p:cNvSpPr txBox="1"/>
          <p:nvPr/>
        </p:nvSpPr>
        <p:spPr>
          <a:xfrm>
            <a:off x="5549604" y="4124714"/>
            <a:ext cx="18582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y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igth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g L</a:t>
            </a:r>
            <a:r>
              <a:rPr lang="de-DE" sz="1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 rot="16200000">
            <a:off x="1377343" y="2121735"/>
            <a:ext cx="33858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etate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sumption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mmol L</a:t>
            </a:r>
            <a:r>
              <a:rPr lang="de-DE" sz="1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Line 8"/>
          <p:cNvSpPr>
            <a:spLocks noChangeShapeType="1"/>
          </p:cNvSpPr>
          <p:nvPr/>
        </p:nvSpPr>
        <p:spPr bwMode="auto">
          <a:xfrm flipV="1">
            <a:off x="8988508" y="847044"/>
            <a:ext cx="0" cy="2917825"/>
          </a:xfrm>
          <a:prstGeom prst="line">
            <a:avLst/>
          </a:prstGeom>
          <a:noFill/>
          <a:ln w="14288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ine 9"/>
          <p:cNvSpPr>
            <a:spLocks noChangeShapeType="1"/>
          </p:cNvSpPr>
          <p:nvPr/>
        </p:nvSpPr>
        <p:spPr bwMode="auto">
          <a:xfrm>
            <a:off x="3658236" y="847044"/>
            <a:ext cx="5319713" cy="0"/>
          </a:xfrm>
          <a:prstGeom prst="line">
            <a:avLst/>
          </a:prstGeom>
          <a:noFill/>
          <a:ln w="14288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cxnSp>
        <p:nvCxnSpPr>
          <p:cNvPr id="38" name="Gerader Verbinder 37"/>
          <p:cNvCxnSpPr>
            <a:stCxn id="3" idx="0"/>
          </p:cNvCxnSpPr>
          <p:nvPr/>
        </p:nvCxnSpPr>
        <p:spPr>
          <a:xfrm flipV="1">
            <a:off x="3636970" y="1379469"/>
            <a:ext cx="5183588" cy="2388803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Oval 14"/>
          <p:cNvSpPr>
            <a:spLocks noChangeArrowheads="1"/>
          </p:cNvSpPr>
          <p:nvPr/>
        </p:nvSpPr>
        <p:spPr bwMode="auto">
          <a:xfrm>
            <a:off x="3751880" y="3626200"/>
            <a:ext cx="112713" cy="112713"/>
          </a:xfrm>
          <a:prstGeom prst="ellipse">
            <a:avLst/>
          </a:prstGeom>
          <a:solidFill>
            <a:srgbClr val="FFFFFF"/>
          </a:solidFill>
          <a:ln w="0">
            <a:solidFill>
              <a:schemeClr val="bg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0" name="Oval 15"/>
          <p:cNvSpPr>
            <a:spLocks noChangeArrowheads="1"/>
          </p:cNvSpPr>
          <p:nvPr/>
        </p:nvSpPr>
        <p:spPr bwMode="auto">
          <a:xfrm>
            <a:off x="3767755" y="3629921"/>
            <a:ext cx="111125" cy="112713"/>
          </a:xfrm>
          <a:prstGeom prst="ellipse">
            <a:avLst/>
          </a:pr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grpSp>
        <p:nvGrpSpPr>
          <p:cNvPr id="41" name="Gruppieren 40"/>
          <p:cNvGrpSpPr/>
          <p:nvPr/>
        </p:nvGrpSpPr>
        <p:grpSpPr>
          <a:xfrm>
            <a:off x="3677004" y="3650231"/>
            <a:ext cx="112713" cy="111125"/>
            <a:chOff x="5622926" y="3925888"/>
            <a:chExt cx="112713" cy="111125"/>
          </a:xfrm>
        </p:grpSpPr>
        <p:sp>
          <p:nvSpPr>
            <p:cNvPr id="42" name="Oval 20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3" name="Oval 21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grpSp>
        <p:nvGrpSpPr>
          <p:cNvPr id="44" name="Gruppieren 43"/>
          <p:cNvGrpSpPr/>
          <p:nvPr/>
        </p:nvGrpSpPr>
        <p:grpSpPr>
          <a:xfrm>
            <a:off x="8212142" y="1323907"/>
            <a:ext cx="112713" cy="111125"/>
            <a:chOff x="5622926" y="3925888"/>
            <a:chExt cx="112713" cy="111125"/>
          </a:xfrm>
        </p:grpSpPr>
        <p:sp>
          <p:nvSpPr>
            <p:cNvPr id="45" name="Oval 20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6" name="Oval 21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grpSp>
        <p:nvGrpSpPr>
          <p:cNvPr id="47" name="Gruppieren 46"/>
          <p:cNvGrpSpPr/>
          <p:nvPr/>
        </p:nvGrpSpPr>
        <p:grpSpPr>
          <a:xfrm>
            <a:off x="8175158" y="1441769"/>
            <a:ext cx="112713" cy="111125"/>
            <a:chOff x="5622926" y="3925888"/>
            <a:chExt cx="112713" cy="111125"/>
          </a:xfrm>
        </p:grpSpPr>
        <p:sp>
          <p:nvSpPr>
            <p:cNvPr id="48" name="Oval 20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9" name="Oval 21"/>
            <p:cNvSpPr>
              <a:spLocks noChangeArrowheads="1"/>
            </p:cNvSpPr>
            <p:nvPr/>
          </p:nvSpPr>
          <p:spPr bwMode="auto">
            <a:xfrm>
              <a:off x="5622926" y="3925888"/>
              <a:ext cx="112713" cy="111125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sp>
        <p:nvSpPr>
          <p:cNvPr id="50" name="Textfeld 49"/>
          <p:cNvSpPr txBox="1"/>
          <p:nvPr/>
        </p:nvSpPr>
        <p:spPr>
          <a:xfrm>
            <a:off x="166507" y="4774680"/>
            <a:ext cx="1186978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pendenc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et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sumptio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dry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matio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onentia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de-DE" sz="1400" i="1" dirty="0">
                <a:latin typeface="Arial" panose="020B0604020202020204" pitchFamily="34" charset="0"/>
                <a:cs typeface="Arial" panose="020B0604020202020204" pitchFamily="34" charset="0"/>
              </a:rPr>
              <a:t>luminyensis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ultur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50 or 500 mL) were grown in complex medium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us 150 mM methanol under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hydrogen atmosphere (2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P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 were taken at different time points and separated by centrifugation 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1 000 x g, 15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in). Cell pellets were used for the determination of the dry weight and culture supernatants for the analysis of the acetate conten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regres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howed that 16.5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mol acetate (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mol carbon atoms) were consum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the course of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formation of 1 g dry weight. Assuming that the dry mass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M. luminyensi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tains 47% carbon (similar to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E. coli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[19]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total amount of carbon sums up to 39.2 mmo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er g dry weight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1 g dry mass  x 0.47 / 12 *1000). In summary, about 84% of cellular carbon derives from acetate. The remaining carbon is most likely obtained from carboxylation reactions (e.g. pyruvat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ynthase (WP_081579999.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WP_019178606.1, WP_026068932.1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P_019178604.1)) and from compounds of the complex medium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uppieren 50"/>
          <p:cNvGrpSpPr/>
          <p:nvPr/>
        </p:nvGrpSpPr>
        <p:grpSpPr>
          <a:xfrm>
            <a:off x="8800054" y="1525030"/>
            <a:ext cx="111125" cy="112713"/>
            <a:chOff x="5261611" y="2561772"/>
            <a:chExt cx="111125" cy="112713"/>
          </a:xfrm>
        </p:grpSpPr>
        <p:sp>
          <p:nvSpPr>
            <p:cNvPr id="52" name="Oval 18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" name="Oval 19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grpSp>
        <p:nvGrpSpPr>
          <p:cNvPr id="54" name="Gruppieren 53"/>
          <p:cNvGrpSpPr/>
          <p:nvPr/>
        </p:nvGrpSpPr>
        <p:grpSpPr>
          <a:xfrm>
            <a:off x="8489994" y="1728744"/>
            <a:ext cx="111125" cy="112713"/>
            <a:chOff x="5261611" y="2561772"/>
            <a:chExt cx="111125" cy="112713"/>
          </a:xfrm>
        </p:grpSpPr>
        <p:sp>
          <p:nvSpPr>
            <p:cNvPr id="55" name="Oval 18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" name="Oval 19"/>
            <p:cNvSpPr>
              <a:spLocks noChangeArrowheads="1"/>
            </p:cNvSpPr>
            <p:nvPr/>
          </p:nvSpPr>
          <p:spPr bwMode="auto">
            <a:xfrm>
              <a:off x="5261611" y="2561772"/>
              <a:ext cx="111125" cy="112713"/>
            </a:xfrm>
            <a:prstGeom prst="ellipse">
              <a:avLst/>
            </a:prstGeom>
            <a:noFill/>
            <a:ln w="142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590980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8</Words>
  <Application>Microsoft Office PowerPoint</Application>
  <PresentationFormat>Breitbild</PresentationFormat>
  <Paragraphs>4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ppenmeier</dc:creator>
  <cp:lastModifiedBy>Deppenmeier</cp:lastModifiedBy>
  <cp:revision>2</cp:revision>
  <dcterms:created xsi:type="dcterms:W3CDTF">2017-09-05T11:23:49Z</dcterms:created>
  <dcterms:modified xsi:type="dcterms:W3CDTF">2017-09-07T09:53:16Z</dcterms:modified>
</cp:coreProperties>
</file>